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2" d="100"/>
          <a:sy n="42" d="100"/>
        </p:scale>
        <p:origin x="92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04D316-26D2-42AF-BF4A-AE763AE6B833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3F9385-FF56-469C-AB6B-18364AFFA4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9227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This Figure</a:t>
            </a:r>
            <a:r>
              <a:rPr lang="en-US" baseline="0" dirty="0" smtClean="0"/>
              <a:t> is un-necessary. Remove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14D6F9C-A449-4B8B-B5DB-DE94C46C66E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59909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6626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138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0235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52160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42308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071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047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508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3949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4754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3908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DD2D0E-E72D-4ECA-AC6C-A1BAB0BA88D0}" type="datetimeFigureOut">
              <a:rPr lang="en-US" smtClean="0"/>
              <a:t>12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FDC5AF-63DE-48D0-8D88-B1E8E39A73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278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/>
          <p:cNvGrpSpPr/>
          <p:nvPr/>
        </p:nvGrpSpPr>
        <p:grpSpPr>
          <a:xfrm>
            <a:off x="1703512" y="2060849"/>
            <a:ext cx="9001000" cy="2765921"/>
            <a:chOff x="179512" y="2060848"/>
            <a:chExt cx="9001000" cy="2765921"/>
          </a:xfrm>
        </p:grpSpPr>
        <p:sp>
          <p:nvSpPr>
            <p:cNvPr id="3" name="TextBox 2"/>
            <p:cNvSpPr txBox="1"/>
            <p:nvPr/>
          </p:nvSpPr>
          <p:spPr>
            <a:xfrm>
              <a:off x="179512" y="2276872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Fusion Results</a:t>
              </a:r>
              <a:endParaRPr lang="en-US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23528" y="2688556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ethod 1</a:t>
              </a:r>
              <a:endParaRPr lang="en-US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60040" y="3225485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Method 2</a:t>
              </a:r>
              <a:endParaRPr lang="en-US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60040" y="3717032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Method 3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602178" y="4180438"/>
              <a:ext cx="208823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ompare with simulated fusions</a:t>
              </a:r>
              <a:endParaRPr lang="en-US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  <p:cxnSp>
          <p:nvCxnSpPr>
            <p:cNvPr id="11" name="直接连接符 10"/>
            <p:cNvCxnSpPr/>
            <p:nvPr/>
          </p:nvCxnSpPr>
          <p:spPr>
            <a:xfrm>
              <a:off x="1367644" y="2873222"/>
              <a:ext cx="2484276" cy="0"/>
            </a:xfrm>
            <a:prstGeom prst="line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/>
            <p:cNvCxnSpPr/>
            <p:nvPr/>
          </p:nvCxnSpPr>
          <p:spPr>
            <a:xfrm>
              <a:off x="1404156" y="3410151"/>
              <a:ext cx="2484276" cy="0"/>
            </a:xfrm>
            <a:prstGeom prst="line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/>
            <p:cNvCxnSpPr/>
            <p:nvPr/>
          </p:nvCxnSpPr>
          <p:spPr>
            <a:xfrm>
              <a:off x="1404156" y="3911305"/>
              <a:ext cx="2484276" cy="0"/>
            </a:xfrm>
            <a:prstGeom prst="line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539552" y="3995772"/>
              <a:ext cx="10081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……</a:t>
              </a:r>
              <a:endParaRPr lang="en-US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275856" y="2060848"/>
              <a:ext cx="259228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True positive number / False positive number</a:t>
              </a:r>
              <a:endParaRPr lang="en-US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3870513" y="2647906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TP / FP 1</a:t>
              </a:r>
              <a:endParaRPr lang="en-US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888432" y="3225485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TP / FP 2</a:t>
              </a:r>
              <a:endParaRPr lang="en-US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3907025" y="3717032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TP / FP 3</a:t>
              </a:r>
              <a:endParaRPr lang="en-US" dirty="0"/>
            </a:p>
          </p:txBody>
        </p:sp>
        <p:cxnSp>
          <p:nvCxnSpPr>
            <p:cNvPr id="22" name="直接连接符 21"/>
            <p:cNvCxnSpPr/>
            <p:nvPr/>
          </p:nvCxnSpPr>
          <p:spPr>
            <a:xfrm>
              <a:off x="4896036" y="2832572"/>
              <a:ext cx="2124236" cy="577579"/>
            </a:xfrm>
            <a:prstGeom prst="line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/>
            <p:cNvCxnSpPr/>
            <p:nvPr/>
          </p:nvCxnSpPr>
          <p:spPr>
            <a:xfrm>
              <a:off x="4932548" y="3410151"/>
              <a:ext cx="2124236" cy="0"/>
            </a:xfrm>
            <a:prstGeom prst="line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连接符 25"/>
            <p:cNvCxnSpPr/>
            <p:nvPr/>
          </p:nvCxnSpPr>
          <p:spPr>
            <a:xfrm flipV="1">
              <a:off x="4932548" y="3410151"/>
              <a:ext cx="2124236" cy="491547"/>
            </a:xfrm>
            <a:prstGeom prst="line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7092280" y="3212976"/>
              <a:ext cx="208823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Summary plot</a:t>
              </a:r>
              <a:endParaRPr lang="en-US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932548" y="4145135"/>
              <a:ext cx="238104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Arial Unicode MS" panose="020B0604020202020204" pitchFamily="34" charset="-122"/>
                  <a:ea typeface="Arial Unicode MS" panose="020B0604020202020204" pitchFamily="34" charset="-122"/>
                  <a:cs typeface="Arial Unicode MS" panose="020B0604020202020204" pitchFamily="34" charset="-122"/>
                </a:rPr>
                <a:t>Calculate Precision and Recall rate</a:t>
              </a:r>
              <a:endParaRPr lang="en-US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6913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7</Words>
  <Application>Microsoft Office PowerPoint</Application>
  <PresentationFormat>Widescreen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 Unicode MS</vt:lpstr>
      <vt:lpstr>宋体</vt:lpstr>
      <vt:lpstr>Arial</vt:lpstr>
      <vt:lpstr>Calibri</vt:lpstr>
      <vt:lpstr>Calibri Light</vt:lpstr>
      <vt:lpstr>Office Theme</vt:lpstr>
      <vt:lpstr>PowerPoint Presentation</vt:lpstr>
    </vt:vector>
  </TitlesOfParts>
  <Company>Boston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xiang.tan</dc:creator>
  <cp:lastModifiedBy>yuxiang.tan</cp:lastModifiedBy>
  <cp:revision>6</cp:revision>
  <dcterms:created xsi:type="dcterms:W3CDTF">2015-12-03T16:22:25Z</dcterms:created>
  <dcterms:modified xsi:type="dcterms:W3CDTF">2015-12-03T16:28:40Z</dcterms:modified>
</cp:coreProperties>
</file>